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3" r:id="rId8"/>
    <p:sldId id="265" r:id="rId9"/>
    <p:sldId id="266" r:id="rId10"/>
    <p:sldId id="264" r:id="rId11"/>
    <p:sldId id="262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378" autoAdjust="0"/>
    <p:restoredTop sz="94660"/>
  </p:normalViewPr>
  <p:slideViewPr>
    <p:cSldViewPr snapToGrid="0">
      <p:cViewPr varScale="1">
        <p:scale>
          <a:sx n="89" d="100"/>
          <a:sy n="89" d="100"/>
        </p:scale>
        <p:origin x="90" y="3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li404\Dropbox\Research%20in%20GT\Figure%206\Obsorbed%20percentage%20in%20viv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li404\Dropbox\Research%20in%20GT\Figure%207\IV%20injection\IV%20injection-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894182931168"/>
          <c:y val="5.90082942180499E-2"/>
          <c:w val="0.84997266574744101"/>
          <c:h val="0.79690867025816103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K$1</c:f>
              <c:strCache>
                <c:ptCount val="1"/>
                <c:pt idx="0">
                  <c:v>Mean</c:v>
                </c:pt>
              </c:strCache>
            </c:strRef>
          </c:tx>
          <c:spPr>
            <a:ln w="38100" cap="rnd">
              <a:solidFill>
                <a:srgbClr val="3333FF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3333FF"/>
              </a:solidFill>
              <a:ln w="9525">
                <a:solidFill>
                  <a:srgbClr val="3333FF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L$2:$L$19</c:f>
                <c:numCache>
                  <c:formatCode>General</c:formatCode>
                  <c:ptCount val="18"/>
                  <c:pt idx="0">
                    <c:v>0.96730479758376597</c:v>
                  </c:pt>
                  <c:pt idx="1">
                    <c:v>2.6888284092306249</c:v>
                  </c:pt>
                  <c:pt idx="2">
                    <c:v>5.9009757062467383</c:v>
                  </c:pt>
                  <c:pt idx="3">
                    <c:v>7.5376118802404974</c:v>
                  </c:pt>
                  <c:pt idx="4">
                    <c:v>9.0856778975012844</c:v>
                  </c:pt>
                  <c:pt idx="5">
                    <c:v>9.3460197792581905</c:v>
                  </c:pt>
                  <c:pt idx="6">
                    <c:v>9.42424826482954</c:v>
                  </c:pt>
                  <c:pt idx="7">
                    <c:v>8.9814153354897694</c:v>
                  </c:pt>
                  <c:pt idx="8">
                    <c:v>8.1646257896926446</c:v>
                  </c:pt>
                  <c:pt idx="9">
                    <c:v>6.8823717620765388</c:v>
                  </c:pt>
                  <c:pt idx="10">
                    <c:v>5.1863171629091198</c:v>
                  </c:pt>
                  <c:pt idx="11">
                    <c:v>4.5099301150746403</c:v>
                  </c:pt>
                  <c:pt idx="12">
                    <c:v>3.4788029037094268</c:v>
                  </c:pt>
                  <c:pt idx="13">
                    <c:v>2.71054257878908</c:v>
                  </c:pt>
                  <c:pt idx="14">
                    <c:v>1.8453629143651631</c:v>
                  </c:pt>
                  <c:pt idx="15">
                    <c:v>1.542066679121608</c:v>
                  </c:pt>
                  <c:pt idx="16">
                    <c:v>1.515307017453184</c:v>
                  </c:pt>
                  <c:pt idx="17">
                    <c:v>1.505257453062431</c:v>
                  </c:pt>
                </c:numCache>
              </c:numRef>
            </c:plus>
            <c:minus>
              <c:numRef>
                <c:f>Sheet1!$L$2:$L$19</c:f>
                <c:numCache>
                  <c:formatCode>General</c:formatCode>
                  <c:ptCount val="18"/>
                  <c:pt idx="0">
                    <c:v>0.96730479758376597</c:v>
                  </c:pt>
                  <c:pt idx="1">
                    <c:v>2.6888284092306249</c:v>
                  </c:pt>
                  <c:pt idx="2">
                    <c:v>5.9009757062467383</c:v>
                  </c:pt>
                  <c:pt idx="3">
                    <c:v>7.5376118802404974</c:v>
                  </c:pt>
                  <c:pt idx="4">
                    <c:v>9.0856778975012844</c:v>
                  </c:pt>
                  <c:pt idx="5">
                    <c:v>9.3460197792581905</c:v>
                  </c:pt>
                  <c:pt idx="6">
                    <c:v>9.42424826482954</c:v>
                  </c:pt>
                  <c:pt idx="7">
                    <c:v>8.9814153354897694</c:v>
                  </c:pt>
                  <c:pt idx="8">
                    <c:v>8.1646257896926446</c:v>
                  </c:pt>
                  <c:pt idx="9">
                    <c:v>6.8823717620765388</c:v>
                  </c:pt>
                  <c:pt idx="10">
                    <c:v>5.1863171629091198</c:v>
                  </c:pt>
                  <c:pt idx="11">
                    <c:v>4.5099301150746403</c:v>
                  </c:pt>
                  <c:pt idx="12">
                    <c:v>3.4788029037094268</c:v>
                  </c:pt>
                  <c:pt idx="13">
                    <c:v>2.71054257878908</c:v>
                  </c:pt>
                  <c:pt idx="14">
                    <c:v>1.8453629143651631</c:v>
                  </c:pt>
                  <c:pt idx="15">
                    <c:v>1.542066679121608</c:v>
                  </c:pt>
                  <c:pt idx="16">
                    <c:v>1.515307017453184</c:v>
                  </c:pt>
                  <c:pt idx="17">
                    <c:v>1.505257453062431</c:v>
                  </c:pt>
                </c:numCache>
              </c:numRef>
            </c:minus>
            <c:spPr>
              <a:noFill/>
              <a:ln w="38100" cap="flat" cmpd="sng" algn="ctr">
                <a:solidFill>
                  <a:srgbClr val="3333FF"/>
                </a:solidFill>
                <a:round/>
              </a:ln>
              <a:effectLst/>
            </c:spPr>
          </c:errBars>
          <c:xVal>
            <c:numRef>
              <c:f>Sheet1!$A$2:$A$21</c:f>
              <c:numCache>
                <c:formatCode>General</c:formatCode>
                <c:ptCount val="20"/>
                <c:pt idx="0">
                  <c:v>1</c:v>
                </c:pt>
                <c:pt idx="1">
                  <c:v>3</c:v>
                </c:pt>
                <c:pt idx="2">
                  <c:v>7</c:v>
                </c:pt>
                <c:pt idx="3">
                  <c:v>10</c:v>
                </c:pt>
                <c:pt idx="4">
                  <c:v>14</c:v>
                </c:pt>
                <c:pt idx="5">
                  <c:v>17</c:v>
                </c:pt>
                <c:pt idx="6">
                  <c:v>21</c:v>
                </c:pt>
                <c:pt idx="7">
                  <c:v>24</c:v>
                </c:pt>
                <c:pt idx="8">
                  <c:v>28</c:v>
                </c:pt>
                <c:pt idx="9">
                  <c:v>31</c:v>
                </c:pt>
                <c:pt idx="10">
                  <c:v>35</c:v>
                </c:pt>
                <c:pt idx="11">
                  <c:v>38</c:v>
                </c:pt>
                <c:pt idx="12">
                  <c:v>42</c:v>
                </c:pt>
                <c:pt idx="13">
                  <c:v>45</c:v>
                </c:pt>
                <c:pt idx="14">
                  <c:v>49</c:v>
                </c:pt>
                <c:pt idx="15">
                  <c:v>52</c:v>
                </c:pt>
                <c:pt idx="16">
                  <c:v>55</c:v>
                </c:pt>
                <c:pt idx="17">
                  <c:v>60</c:v>
                </c:pt>
              </c:numCache>
            </c:numRef>
          </c:xVal>
          <c:yVal>
            <c:numRef>
              <c:f>Sheet1!$K$2:$K$21</c:f>
              <c:numCache>
                <c:formatCode>General</c:formatCode>
                <c:ptCount val="20"/>
                <c:pt idx="0">
                  <c:v>2.5825</c:v>
                </c:pt>
                <c:pt idx="1">
                  <c:v>9.4237500000000001</c:v>
                </c:pt>
                <c:pt idx="2">
                  <c:v>26.07</c:v>
                </c:pt>
                <c:pt idx="3">
                  <c:v>36.747500000000002</c:v>
                </c:pt>
                <c:pt idx="4">
                  <c:v>48.704999999999998</c:v>
                </c:pt>
                <c:pt idx="5">
                  <c:v>56.635000000000012</c:v>
                </c:pt>
                <c:pt idx="6">
                  <c:v>66.956249999999997</c:v>
                </c:pt>
                <c:pt idx="7">
                  <c:v>73.217500000000001</c:v>
                </c:pt>
                <c:pt idx="8">
                  <c:v>80.705000000000013</c:v>
                </c:pt>
                <c:pt idx="9">
                  <c:v>84.608749999999972</c:v>
                </c:pt>
                <c:pt idx="10">
                  <c:v>88.09</c:v>
                </c:pt>
                <c:pt idx="11">
                  <c:v>90.248750000000001</c:v>
                </c:pt>
                <c:pt idx="12">
                  <c:v>93.438749999999999</c:v>
                </c:pt>
                <c:pt idx="13">
                  <c:v>95.798749999999998</c:v>
                </c:pt>
                <c:pt idx="14">
                  <c:v>97.68249999999999</c:v>
                </c:pt>
                <c:pt idx="15">
                  <c:v>98.396249999999995</c:v>
                </c:pt>
                <c:pt idx="16">
                  <c:v>98.788749999999979</c:v>
                </c:pt>
                <c:pt idx="17">
                  <c:v>99.165000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AFA-42C7-8BF1-8132718F47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4993680"/>
        <c:axId val="1654996000"/>
      </c:scatterChart>
      <c:valAx>
        <c:axId val="1654993680"/>
        <c:scaling>
          <c:orientation val="minMax"/>
          <c:max val="61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508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4996000"/>
        <c:crosses val="autoZero"/>
        <c:crossBetween val="midCat"/>
        <c:majorUnit val="10"/>
      </c:valAx>
      <c:valAx>
        <c:axId val="1654996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508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549936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L$1</c:f>
              <c:strCache>
                <c:ptCount val="1"/>
                <c:pt idx="0">
                  <c:v>average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M$2:$M$9</c:f>
                <c:numCache>
                  <c:formatCode>General</c:formatCode>
                  <c:ptCount val="8"/>
                  <c:pt idx="0">
                    <c:v>318.54208905574785</c:v>
                  </c:pt>
                  <c:pt idx="1">
                    <c:v>183.23405455864366</c:v>
                  </c:pt>
                  <c:pt idx="2">
                    <c:v>117.36651327146087</c:v>
                  </c:pt>
                  <c:pt idx="3">
                    <c:v>71.804855772433669</c:v>
                  </c:pt>
                  <c:pt idx="4">
                    <c:v>5.7531241512764231</c:v>
                  </c:pt>
                  <c:pt idx="5">
                    <c:v>6.075642970089671</c:v>
                  </c:pt>
                  <c:pt idx="6">
                    <c:v>2.748307433676227</c:v>
                  </c:pt>
                  <c:pt idx="7">
                    <c:v>2.7145337997527328</c:v>
                  </c:pt>
                </c:numCache>
              </c:numRef>
            </c:plus>
            <c:minus>
              <c:numRef>
                <c:f>Sheet1!$M$2:$M$9</c:f>
                <c:numCache>
                  <c:formatCode>General</c:formatCode>
                  <c:ptCount val="8"/>
                  <c:pt idx="0">
                    <c:v>318.54208905574785</c:v>
                  </c:pt>
                  <c:pt idx="1">
                    <c:v>183.23405455864366</c:v>
                  </c:pt>
                  <c:pt idx="2">
                    <c:v>117.36651327146087</c:v>
                  </c:pt>
                  <c:pt idx="3">
                    <c:v>71.804855772433669</c:v>
                  </c:pt>
                  <c:pt idx="4">
                    <c:v>5.7531241512764231</c:v>
                  </c:pt>
                  <c:pt idx="5">
                    <c:v>6.075642970089671</c:v>
                  </c:pt>
                  <c:pt idx="6">
                    <c:v>2.748307433676227</c:v>
                  </c:pt>
                  <c:pt idx="7">
                    <c:v>2.7145337997527328</c:v>
                  </c:pt>
                </c:numCache>
              </c:numRef>
            </c:minus>
            <c:spPr>
              <a:noFill/>
              <a:ln w="31750" cap="flat" cmpd="sng" algn="ctr">
                <a:solidFill>
                  <a:srgbClr val="FF0000"/>
                </a:solidFill>
                <a:round/>
              </a:ln>
              <a:effectLst/>
            </c:spPr>
          </c:errBars>
          <c:xVal>
            <c:numRef>
              <c:f>Sheet1!$K$2:$K$9</c:f>
              <c:numCache>
                <c:formatCode>General</c:formatCode>
                <c:ptCount val="8"/>
                <c:pt idx="0">
                  <c:v>0.17</c:v>
                </c:pt>
                <c:pt idx="1">
                  <c:v>0.67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8</c:v>
                </c:pt>
                <c:pt idx="6">
                  <c:v>24</c:v>
                </c:pt>
                <c:pt idx="7">
                  <c:v>48</c:v>
                </c:pt>
              </c:numCache>
            </c:numRef>
          </c:xVal>
          <c:yVal>
            <c:numRef>
              <c:f>Sheet1!$L$2:$L$9</c:f>
              <c:numCache>
                <c:formatCode>General</c:formatCode>
                <c:ptCount val="8"/>
                <c:pt idx="0">
                  <c:v>16536</c:v>
                </c:pt>
                <c:pt idx="1">
                  <c:v>3255.5</c:v>
                </c:pt>
                <c:pt idx="2">
                  <c:v>1867.375</c:v>
                </c:pt>
                <c:pt idx="3">
                  <c:v>941.88000000000011</c:v>
                </c:pt>
                <c:pt idx="4">
                  <c:v>341.05</c:v>
                </c:pt>
                <c:pt idx="5">
                  <c:v>346.9</c:v>
                </c:pt>
                <c:pt idx="6">
                  <c:v>103.8075</c:v>
                </c:pt>
                <c:pt idx="7">
                  <c:v>89.1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86E-4C58-9584-D0D85F99BC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6015344"/>
        <c:axId val="396013048"/>
      </c:scatterChart>
      <c:valAx>
        <c:axId val="396015344"/>
        <c:scaling>
          <c:orientation val="minMax"/>
          <c:max val="5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444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96013048"/>
        <c:crosses val="autoZero"/>
        <c:crossBetween val="midCat"/>
      </c:valAx>
      <c:valAx>
        <c:axId val="396013048"/>
        <c:scaling>
          <c:logBase val="10"/>
          <c:orientation val="minMax"/>
          <c:max val="17500"/>
          <c:min val="80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444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960153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A3FB64-1C57-4D34-9C41-74D9736889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FEEB32-7AEF-4088-8DDE-10AE647ACA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DA42FA-7E4E-493B-92DA-BA1DD2368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B397DA-5660-4465-ADA7-DE26CE763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012DE5-474B-4E5A-A74F-3B228DF15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133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EE3D0D-00FB-46AD-A4A5-C69545274B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FD514F-1C0C-4F1C-9B19-20B640F838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580F50-E34E-41BD-839F-84026D0A8C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B8DFF8-2CF6-4219-AF1B-242A12A99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DA8BB2-461F-4804-B93A-B31BC3E43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3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3BBB64-8822-4468-A135-5B3D41B370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0418B9-D353-484F-A518-EC43759A5A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A1C339-F83A-4179-A13A-F98A194C0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E312D2-60D5-40CE-A3AE-45CA965A5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3930F6-5440-4395-8084-F585188C5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139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386DCF-2E27-4BC7-ADF4-947EC24853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A27591-A5EA-4016-BCC3-84D0994E7B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D81515-38A2-40DC-B74A-8099E6B09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FE8429-48E8-4D59-8375-7E72F9BFB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84A135-351C-41C7-9957-FEF0ED6F60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816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0F1476-9438-4268-B820-F4310A279C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306C36-094A-464E-A278-B3A5E7254A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08DD2D-2DD9-4550-8702-2E7316BF7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A768FD-B578-4BA9-890C-31E8635C1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1C0F4C-5D8A-499D-98AB-472D41E9B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256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26D50-63FA-4C5B-9C95-755186D687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ED7A76-2047-4E93-8E8A-75FE6F087C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2D1C56-8AA8-470A-AE68-74815AD053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CABE9B-6D1C-4AB5-B206-003F7A7FB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94FF61-CE9B-42DC-AE2D-D123948FA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730AE2-2F06-413E-AF1B-355A743BC2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840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E2541-D36E-4CF5-826A-0C06574CC1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FA1E95-7324-44AA-B98C-6A75C5FD05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353F7A-E596-4CCA-BFC7-F9DD480B5F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0B0ACA-E151-4C9B-AB25-0B8ABC0D79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46F61C-5A13-428C-816F-0D1D6A19D7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1FF257-B113-40BF-8C1E-709FC6D68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53C933-7CA0-468E-A56E-46A391E63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30CE9D5-A34E-4E79-A54C-E0917CCE1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063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78E092-633E-4BEE-9BE5-F71E02ADD6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F2A37C3-A1A8-4A24-9F93-B945C2A23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E7EAA0-8AA4-4B2F-B611-87A5FFD21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068009-4575-4D78-88AA-DE193F0EE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081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F7D31B-7442-432C-9F45-1C39F2855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4AF36B-4B62-4CA1-B781-EE0F8499D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5D5676-9E93-431C-A677-30C294129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95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9CC0C6-F0A2-42B2-9879-1A24C14739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554E4E-E853-46A1-AE0F-08FEF01666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AECC60-0503-4B70-8D66-98B083FDE9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A91D25-093A-4E85-885E-AA9E7144C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DBA123-1DA7-41EA-BF96-507DF2CD96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EE4EF2-9A67-4922-8164-88123D329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806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3CD58A-75FC-421C-B90A-2C01750550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75B7BA-C715-42AF-B043-DE64E0E455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B85F65-2EB1-473C-AD34-DDAD98BBF5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38111A-53E1-460A-821B-CBB5C63A0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798E98-D87B-429F-AE4F-2D8B7DA72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6F2D2D-E83C-4BC6-AF0A-921A0E12D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824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EFBCF0-FC0C-4C58-AA75-4397E2298C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5BE687-E183-45EA-A2CA-97F9A7EE71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17968E-D152-4C4B-AD4D-D6C681FAB3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DA73B4-6ECD-4231-92ED-E4074151536F}" type="datetimeFigureOut">
              <a:rPr lang="en-US" smtClean="0"/>
              <a:t>11/11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C4F68A-A4A8-47BC-9525-A8A5B8AC5E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FD4613-DCB9-46DB-8D6C-873E0223EE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73F867-692B-4202-83A1-7A7BF560AE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240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7.ti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3.bin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FC684E6-D7C7-4C4E-BF11-3D750AA9B8A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72164" y="787543"/>
            <a:ext cx="3764477" cy="2756107"/>
          </a:xfrm>
          <a:prstGeom prst="rect">
            <a:avLst/>
          </a:prstGeom>
        </p:spPr>
      </p:pic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DD6AF11-AF53-4D4D-8D22-1F8415E553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9509928"/>
              </p:ext>
            </p:extLst>
          </p:nvPr>
        </p:nvGraphicFramePr>
        <p:xfrm>
          <a:off x="1235034" y="3971689"/>
          <a:ext cx="9524010" cy="11074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04802">
                  <a:extLst>
                    <a:ext uri="{9D8B030D-6E8A-4147-A177-3AD203B41FA5}">
                      <a16:colId xmlns:a16="http://schemas.microsoft.com/office/drawing/2014/main" val="748149753"/>
                    </a:ext>
                  </a:extLst>
                </a:gridCol>
                <a:gridCol w="1904802">
                  <a:extLst>
                    <a:ext uri="{9D8B030D-6E8A-4147-A177-3AD203B41FA5}">
                      <a16:colId xmlns:a16="http://schemas.microsoft.com/office/drawing/2014/main" val="1373934484"/>
                    </a:ext>
                  </a:extLst>
                </a:gridCol>
                <a:gridCol w="1904802">
                  <a:extLst>
                    <a:ext uri="{9D8B030D-6E8A-4147-A177-3AD203B41FA5}">
                      <a16:colId xmlns:a16="http://schemas.microsoft.com/office/drawing/2014/main" val="3990329361"/>
                    </a:ext>
                  </a:extLst>
                </a:gridCol>
                <a:gridCol w="1904802">
                  <a:extLst>
                    <a:ext uri="{9D8B030D-6E8A-4147-A177-3AD203B41FA5}">
                      <a16:colId xmlns:a16="http://schemas.microsoft.com/office/drawing/2014/main" val="312132712"/>
                    </a:ext>
                  </a:extLst>
                </a:gridCol>
                <a:gridCol w="1904802">
                  <a:extLst>
                    <a:ext uri="{9D8B030D-6E8A-4147-A177-3AD203B41FA5}">
                      <a16:colId xmlns:a16="http://schemas.microsoft.com/office/drawing/2014/main" val="1998902553"/>
                    </a:ext>
                  </a:extLst>
                </a:gridCol>
              </a:tblGrid>
              <a:tr h="139250">
                <a:tc>
                  <a:txBody>
                    <a:bodyPr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30 µl backing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50 µl backing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70 µl backing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90 µl backing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57910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Height of bubble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310.0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38.5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61.0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05.75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728315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err="1"/>
                        <a:t>sd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6.46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6.3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0.02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1.79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38944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910867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3421B3F-FB9F-40AC-9911-C04BED9179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2556" y="279024"/>
            <a:ext cx="4153276" cy="3811076"/>
          </a:xfrm>
          <a:prstGeom prst="rect">
            <a:avLst/>
          </a:prstGeom>
        </p:spPr>
      </p:pic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5E73D38-80D5-4FCA-A67C-9855088E2B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7780081"/>
              </p:ext>
            </p:extLst>
          </p:nvPr>
        </p:nvGraphicFramePr>
        <p:xfrm>
          <a:off x="1074570" y="4431055"/>
          <a:ext cx="8128000" cy="1112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32000">
                  <a:extLst>
                    <a:ext uri="{9D8B030D-6E8A-4147-A177-3AD203B41FA5}">
                      <a16:colId xmlns:a16="http://schemas.microsoft.com/office/drawing/2014/main" val="91272790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2798644421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2526713408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339849453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onditions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 h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8 h without light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8 with light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5784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Normalized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996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973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9623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err="1"/>
                        <a:t>sd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05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2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86122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323547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0249525"/>
              </p:ext>
            </p:extLst>
          </p:nvPr>
        </p:nvGraphicFramePr>
        <p:xfrm>
          <a:off x="8126534" y="1077814"/>
          <a:ext cx="3018390" cy="467890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06130">
                  <a:extLst>
                    <a:ext uri="{9D8B030D-6E8A-4147-A177-3AD203B41FA5}">
                      <a16:colId xmlns:a16="http://schemas.microsoft.com/office/drawing/2014/main" val="2719737822"/>
                    </a:ext>
                  </a:extLst>
                </a:gridCol>
                <a:gridCol w="1006130">
                  <a:extLst>
                    <a:ext uri="{9D8B030D-6E8A-4147-A177-3AD203B41FA5}">
                      <a16:colId xmlns:a16="http://schemas.microsoft.com/office/drawing/2014/main" val="4294839348"/>
                    </a:ext>
                  </a:extLst>
                </a:gridCol>
                <a:gridCol w="1006130">
                  <a:extLst>
                    <a:ext uri="{9D8B030D-6E8A-4147-A177-3AD203B41FA5}">
                      <a16:colId xmlns:a16="http://schemas.microsoft.com/office/drawing/2014/main" val="4196313362"/>
                    </a:ext>
                  </a:extLst>
                </a:gridCol>
              </a:tblGrid>
              <a:tr h="5198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</a:t>
                      </a: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h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(</a:t>
                      </a:r>
                      <a:r>
                        <a:rPr lang="en-US" sz="14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</a:t>
                      </a:r>
                      <a:r>
                        <a:rPr lang="en-US" sz="14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ml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2099758"/>
                  </a:ext>
                </a:extLst>
              </a:tr>
              <a:tr h="5198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3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8.542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7261582"/>
                  </a:ext>
                </a:extLst>
              </a:tr>
              <a:tr h="5198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55.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3.234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2051949"/>
                  </a:ext>
                </a:extLst>
              </a:tr>
              <a:tr h="5198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7.37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.366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2299316"/>
                  </a:ext>
                </a:extLst>
              </a:tr>
              <a:tr h="5198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1.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8048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3325214"/>
                  </a:ext>
                </a:extLst>
              </a:tr>
              <a:tr h="5198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1.0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5312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6179380"/>
                  </a:ext>
                </a:extLst>
              </a:tr>
              <a:tr h="5198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6.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7564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278490"/>
                  </a:ext>
                </a:extLst>
              </a:tr>
              <a:tr h="5198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.807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4830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268860"/>
                  </a:ext>
                </a:extLst>
              </a:tr>
              <a:tr h="51987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.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1453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9044839"/>
                  </a:ext>
                </a:extLst>
              </a:tr>
            </a:tbl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5739191"/>
              </p:ext>
            </p:extLst>
          </p:nvPr>
        </p:nvGraphicFramePr>
        <p:xfrm>
          <a:off x="2268570" y="946211"/>
          <a:ext cx="5218752" cy="42957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216998" y="5241986"/>
            <a:ext cx="1904103" cy="381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645459" y="2770932"/>
            <a:ext cx="24419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LNG concentration (</a:t>
            </a:r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18647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CC519D8-D5CF-483B-BE2F-A024A53B602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63684" y="215496"/>
            <a:ext cx="3247411" cy="3689468"/>
          </a:xfrm>
          <a:prstGeom prst="rect">
            <a:avLst/>
          </a:prstGeom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8EEB4C8-98DB-48D0-8192-82FD249C76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042154"/>
              </p:ext>
            </p:extLst>
          </p:nvPr>
        </p:nvGraphicFramePr>
        <p:xfrm>
          <a:off x="774552" y="4208474"/>
          <a:ext cx="10585521" cy="16573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16314">
                  <a:extLst>
                    <a:ext uri="{9D8B030D-6E8A-4147-A177-3AD203B41FA5}">
                      <a16:colId xmlns:a16="http://schemas.microsoft.com/office/drawing/2014/main" val="620540384"/>
                    </a:ext>
                  </a:extLst>
                </a:gridCol>
                <a:gridCol w="1408121">
                  <a:extLst>
                    <a:ext uri="{9D8B030D-6E8A-4147-A177-3AD203B41FA5}">
                      <a16:colId xmlns:a16="http://schemas.microsoft.com/office/drawing/2014/main" val="2953352058"/>
                    </a:ext>
                  </a:extLst>
                </a:gridCol>
                <a:gridCol w="1512217">
                  <a:extLst>
                    <a:ext uri="{9D8B030D-6E8A-4147-A177-3AD203B41FA5}">
                      <a16:colId xmlns:a16="http://schemas.microsoft.com/office/drawing/2014/main" val="2930663945"/>
                    </a:ext>
                  </a:extLst>
                </a:gridCol>
                <a:gridCol w="1802945">
                  <a:extLst>
                    <a:ext uri="{9D8B030D-6E8A-4147-A177-3AD203B41FA5}">
                      <a16:colId xmlns:a16="http://schemas.microsoft.com/office/drawing/2014/main" val="2445187512"/>
                    </a:ext>
                  </a:extLst>
                </a:gridCol>
                <a:gridCol w="1221490">
                  <a:extLst>
                    <a:ext uri="{9D8B030D-6E8A-4147-A177-3AD203B41FA5}">
                      <a16:colId xmlns:a16="http://schemas.microsoft.com/office/drawing/2014/main" val="1039466866"/>
                    </a:ext>
                  </a:extLst>
                </a:gridCol>
                <a:gridCol w="1512217">
                  <a:extLst>
                    <a:ext uri="{9D8B030D-6E8A-4147-A177-3AD203B41FA5}">
                      <a16:colId xmlns:a16="http://schemas.microsoft.com/office/drawing/2014/main" val="1933169223"/>
                    </a:ext>
                  </a:extLst>
                </a:gridCol>
                <a:gridCol w="1512217">
                  <a:extLst>
                    <a:ext uri="{9D8B030D-6E8A-4147-A177-3AD203B41FA5}">
                      <a16:colId xmlns:a16="http://schemas.microsoft.com/office/drawing/2014/main" val="301439409"/>
                    </a:ext>
                  </a:extLst>
                </a:gridCol>
              </a:tblGrid>
              <a:tr h="499104"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Penetration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err="1"/>
                        <a:t>sd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Detachment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err="1"/>
                        <a:t>sd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Delivery of dye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err="1"/>
                        <a:t>sd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01380388"/>
                  </a:ext>
                </a:extLst>
              </a:tr>
              <a:tr h="499104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Microneedle with bubbles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97.60</a:t>
                      </a:r>
                    </a:p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.30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96.00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3.65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91.12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5.44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6102135"/>
                  </a:ext>
                </a:extLst>
              </a:tr>
              <a:tr h="499104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Microneedle without bubbles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/>
                        <a:t>99.20</a:t>
                      </a:r>
                    </a:p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.89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5.00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2.50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9.23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3.70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010384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20399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8C20309-420A-44B9-B6CA-AF44785ADDB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12997" y="135328"/>
            <a:ext cx="4542849" cy="3012685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369703C-D0E3-4F4C-85C6-3B81D007BF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1276672"/>
              </p:ext>
            </p:extLst>
          </p:nvPr>
        </p:nvGraphicFramePr>
        <p:xfrm>
          <a:off x="571761" y="3287863"/>
          <a:ext cx="10568825" cy="33886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Worksheet" r:id="rId4" imgW="8496367" imgH="2724253" progId="Excel.Sheet.12">
                  <p:embed/>
                </p:oleObj>
              </mc:Choice>
              <mc:Fallback>
                <p:oleObj name="Worksheet" r:id="rId4" imgW="8496367" imgH="2724253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71761" y="3287863"/>
                        <a:ext cx="10568825" cy="33886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908054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9E4868B-1F42-45F9-8408-B54FFA23000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07497" y="11877"/>
            <a:ext cx="4681106" cy="246888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0815402-AED8-4001-8763-2A9214E58FF7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8444" y="2"/>
            <a:ext cx="4572000" cy="31293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80259A2-C8CE-46AF-B314-804B350E4828}"/>
              </a:ext>
            </a:extLst>
          </p:cNvPr>
          <p:cNvSpPr txBox="1"/>
          <p:nvPr/>
        </p:nvSpPr>
        <p:spPr>
          <a:xfrm>
            <a:off x="2947487" y="2362008"/>
            <a:ext cx="1929444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ime (day)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8CBB19C-F4BE-487B-8624-CC2DCBF434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6565157"/>
              </p:ext>
            </p:extLst>
          </p:nvPr>
        </p:nvGraphicFramePr>
        <p:xfrm>
          <a:off x="1878869" y="2676525"/>
          <a:ext cx="8439150" cy="4181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1" name="Worksheet" r:id="rId5" imgW="8439184" imgH="4181349" progId="Excel.Sheet.12">
                  <p:embed/>
                </p:oleObj>
              </mc:Choice>
              <mc:Fallback>
                <p:oleObj name="Worksheet" r:id="rId5" imgW="8439184" imgH="4181349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78869" y="2676525"/>
                        <a:ext cx="8439150" cy="4181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411079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6EBE8919-14FD-4594-9B2D-4763922F0F6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0433996"/>
              </p:ext>
            </p:extLst>
          </p:nvPr>
        </p:nvGraphicFramePr>
        <p:xfrm>
          <a:off x="2081116" y="2149712"/>
          <a:ext cx="4183537" cy="24177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3">
            <a:extLst>
              <a:ext uri="{FF2B5EF4-FFF2-40B4-BE49-F238E27FC236}">
                <a16:creationId xmlns:a16="http://schemas.microsoft.com/office/drawing/2014/main" id="{FB330CFD-ABEA-4E1C-ABD7-64D661CB38B0}"/>
              </a:ext>
            </a:extLst>
          </p:cNvPr>
          <p:cNvSpPr txBox="1"/>
          <p:nvPr/>
        </p:nvSpPr>
        <p:spPr>
          <a:xfrm rot="16200000">
            <a:off x="292172" y="2952315"/>
            <a:ext cx="27144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umulative LNG absorbed in vivo (%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23B419A-A6C5-43DC-8453-FA62EF9B8DF0}"/>
              </a:ext>
            </a:extLst>
          </p:cNvPr>
          <p:cNvSpPr txBox="1"/>
          <p:nvPr/>
        </p:nvSpPr>
        <p:spPr>
          <a:xfrm>
            <a:off x="3425435" y="4474516"/>
            <a:ext cx="1929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ime (day)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9752913"/>
              </p:ext>
            </p:extLst>
          </p:nvPr>
        </p:nvGraphicFramePr>
        <p:xfrm>
          <a:off x="6807770" y="1592140"/>
          <a:ext cx="3214218" cy="44533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71406">
                  <a:extLst>
                    <a:ext uri="{9D8B030D-6E8A-4147-A177-3AD203B41FA5}">
                      <a16:colId xmlns:a16="http://schemas.microsoft.com/office/drawing/2014/main" val="1868012707"/>
                    </a:ext>
                  </a:extLst>
                </a:gridCol>
                <a:gridCol w="1071406">
                  <a:extLst>
                    <a:ext uri="{9D8B030D-6E8A-4147-A177-3AD203B41FA5}">
                      <a16:colId xmlns:a16="http://schemas.microsoft.com/office/drawing/2014/main" val="120656931"/>
                    </a:ext>
                  </a:extLst>
                </a:gridCol>
                <a:gridCol w="1071406">
                  <a:extLst>
                    <a:ext uri="{9D8B030D-6E8A-4147-A177-3AD203B41FA5}">
                      <a16:colId xmlns:a16="http://schemas.microsoft.com/office/drawing/2014/main" val="3726217618"/>
                    </a:ext>
                  </a:extLst>
                </a:gridCol>
              </a:tblGrid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smtClean="0">
                          <a:effectLst/>
                        </a:rPr>
                        <a:t>Time </a:t>
                      </a:r>
                      <a:r>
                        <a:rPr lang="en-US" sz="1400" u="none" strike="noStrike" dirty="0">
                          <a:effectLst/>
                        </a:rPr>
                        <a:t>(d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Me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s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8349665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.582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967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6301666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.423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.68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9645939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6.07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.90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0537722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6.747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7.537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5116874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8.70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.085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3552711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6.63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.346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0622222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6.956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.424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6034982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73.217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8.981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5411973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80.70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8.164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2195221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84.60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.882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7367650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88.09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.186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4539419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0.24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.509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5561538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3.43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.47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3716296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5.79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.710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2433417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4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7.682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.845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5263027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8.396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.542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6294871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5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8.788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.515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3181895"/>
                  </a:ext>
                </a:extLst>
              </a:tr>
              <a:tr h="2343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6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99.16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1.505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90818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227582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DD04603F-82D6-4916-A74F-1147F167927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03805" y="296884"/>
            <a:ext cx="4588743" cy="3931920"/>
          </a:xfrm>
          <a:prstGeom prst="rect">
            <a:avLst/>
          </a:prstGeom>
        </p:spPr>
      </p:pic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21C433E-9312-4892-A3AB-99331223B0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7521016"/>
              </p:ext>
            </p:extLst>
          </p:nvPr>
        </p:nvGraphicFramePr>
        <p:xfrm>
          <a:off x="595651" y="4519858"/>
          <a:ext cx="10882758" cy="11074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54491">
                  <a:extLst>
                    <a:ext uri="{9D8B030D-6E8A-4147-A177-3AD203B41FA5}">
                      <a16:colId xmlns:a16="http://schemas.microsoft.com/office/drawing/2014/main" val="805374801"/>
                    </a:ext>
                  </a:extLst>
                </a:gridCol>
                <a:gridCol w="1066197">
                  <a:extLst>
                    <a:ext uri="{9D8B030D-6E8A-4147-A177-3AD203B41FA5}">
                      <a16:colId xmlns:a16="http://schemas.microsoft.com/office/drawing/2014/main" val="689969213"/>
                    </a:ext>
                  </a:extLst>
                </a:gridCol>
                <a:gridCol w="1360345">
                  <a:extLst>
                    <a:ext uri="{9D8B030D-6E8A-4147-A177-3AD203B41FA5}">
                      <a16:colId xmlns:a16="http://schemas.microsoft.com/office/drawing/2014/main" val="3240095005"/>
                    </a:ext>
                  </a:extLst>
                </a:gridCol>
                <a:gridCol w="1360345">
                  <a:extLst>
                    <a:ext uri="{9D8B030D-6E8A-4147-A177-3AD203B41FA5}">
                      <a16:colId xmlns:a16="http://schemas.microsoft.com/office/drawing/2014/main" val="1027389152"/>
                    </a:ext>
                  </a:extLst>
                </a:gridCol>
                <a:gridCol w="1360345">
                  <a:extLst>
                    <a:ext uri="{9D8B030D-6E8A-4147-A177-3AD203B41FA5}">
                      <a16:colId xmlns:a16="http://schemas.microsoft.com/office/drawing/2014/main" val="3204207083"/>
                    </a:ext>
                  </a:extLst>
                </a:gridCol>
                <a:gridCol w="1360345">
                  <a:extLst>
                    <a:ext uri="{9D8B030D-6E8A-4147-A177-3AD203B41FA5}">
                      <a16:colId xmlns:a16="http://schemas.microsoft.com/office/drawing/2014/main" val="1867334583"/>
                    </a:ext>
                  </a:extLst>
                </a:gridCol>
                <a:gridCol w="1360345">
                  <a:extLst>
                    <a:ext uri="{9D8B030D-6E8A-4147-A177-3AD203B41FA5}">
                      <a16:colId xmlns:a16="http://schemas.microsoft.com/office/drawing/2014/main" val="2128134493"/>
                    </a:ext>
                  </a:extLst>
                </a:gridCol>
                <a:gridCol w="1360345">
                  <a:extLst>
                    <a:ext uri="{9D8B030D-6E8A-4147-A177-3AD203B41FA5}">
                      <a16:colId xmlns:a16="http://schemas.microsoft.com/office/drawing/2014/main" val="424585575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ime (day)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7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5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3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45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6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858790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Normalized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95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77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66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32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5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1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18419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err="1"/>
                        <a:t>sd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5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8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2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6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4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96404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606842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2AFC96B-5715-4E6F-8B0F-EA2243EBC28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52194" y="385037"/>
            <a:ext cx="4049485" cy="3963018"/>
          </a:xfrm>
          <a:prstGeom prst="rect">
            <a:avLst/>
          </a:prstGeom>
        </p:spPr>
      </p:pic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4FF3E6B-B226-4512-8D31-F7C476FB94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507498"/>
              </p:ext>
            </p:extLst>
          </p:nvPr>
        </p:nvGraphicFramePr>
        <p:xfrm>
          <a:off x="837900" y="4678479"/>
          <a:ext cx="8127999" cy="1112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09333">
                  <a:extLst>
                    <a:ext uri="{9D8B030D-6E8A-4147-A177-3AD203B41FA5}">
                      <a16:colId xmlns:a16="http://schemas.microsoft.com/office/drawing/2014/main" val="3631606402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2603736319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99454994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Before scraping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After scraping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26676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ean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96.2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94.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86594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err="1"/>
                        <a:t>sd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3.7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5.1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130295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110663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94E3BDD-EABC-4837-8DDE-DD9B925AF4E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29443" y="89926"/>
            <a:ext cx="5294644" cy="3413761"/>
          </a:xfrm>
          <a:prstGeom prst="rect">
            <a:avLst/>
          </a:prstGeom>
        </p:spPr>
      </p:pic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D94F378-2AFB-4660-A567-D2ED23DC36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4629529"/>
              </p:ext>
            </p:extLst>
          </p:nvPr>
        </p:nvGraphicFramePr>
        <p:xfrm>
          <a:off x="517973" y="3503687"/>
          <a:ext cx="10687050" cy="2724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30" name="Worksheet" r:id="rId4" imgW="10687151" imgH="2724253" progId="Excel.Sheet.12">
                  <p:embed/>
                </p:oleObj>
              </mc:Choice>
              <mc:Fallback>
                <p:oleObj name="Worksheet" r:id="rId4" imgW="10687151" imgH="2724253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7973" y="3503687"/>
                        <a:ext cx="10687050" cy="2724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62838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7627E5A-3E97-44F8-9F1E-BFA6A193B0B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5" t="53705" r="65039"/>
          <a:stretch/>
        </p:blipFill>
        <p:spPr>
          <a:xfrm>
            <a:off x="2636321" y="415636"/>
            <a:ext cx="4026685" cy="3621974"/>
          </a:xfrm>
          <a:prstGeom prst="rect">
            <a:avLst/>
          </a:prstGeom>
        </p:spPr>
      </p:pic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AE48E2E-059E-4709-951B-C4E9D0B332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5923865"/>
              </p:ext>
            </p:extLst>
          </p:nvPr>
        </p:nvGraphicFramePr>
        <p:xfrm>
          <a:off x="1440329" y="4344993"/>
          <a:ext cx="8128000" cy="1112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32000">
                  <a:extLst>
                    <a:ext uri="{9D8B030D-6E8A-4147-A177-3AD203B41FA5}">
                      <a16:colId xmlns:a16="http://schemas.microsoft.com/office/drawing/2014/main" val="367799086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833323378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1450924220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152637659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ime (h)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 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8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8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57234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Normalized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36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2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54311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err="1"/>
                        <a:t>sd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5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00</a:t>
                      </a: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31572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20276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236</Words>
  <Application>Microsoft Office PowerPoint</Application>
  <PresentationFormat>Widescreen</PresentationFormat>
  <Paragraphs>179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Wei</dc:creator>
  <cp:lastModifiedBy>Li, Wei</cp:lastModifiedBy>
  <cp:revision>29</cp:revision>
  <dcterms:created xsi:type="dcterms:W3CDTF">2018-03-23T17:57:37Z</dcterms:created>
  <dcterms:modified xsi:type="dcterms:W3CDTF">2018-11-12T02:52:40Z</dcterms:modified>
</cp:coreProperties>
</file>